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12193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CF549-71EF-4007-9104-3432A47589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5914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7285320"/>
            <a:ext cx="5914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79280C-A1CE-4684-8CE9-8FF9D44C76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5952E-767D-4480-BDD6-238C3C6B41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3244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3244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7285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7285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7285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E53D9D-B51E-47D3-9C42-2AEA2F35E9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3244320"/>
            <a:ext cx="5914800" cy="773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37159F-2B3B-4A95-B3CC-A77455A4FE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59148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F8BD7E-F96F-4E27-AA6B-3561EDFD74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6B2AF9-5355-46F7-8C78-90B7B6DB40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21A814-939E-4387-B231-4DD7D07833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649440"/>
            <a:ext cx="5914800" cy="10921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90FCAC-805C-4C92-87CB-7D61771416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4B6887-BC41-4EE3-9939-1FA7B6D2F4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429375-1F2C-48BA-B6A7-2F6B2835FA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7285320"/>
            <a:ext cx="5914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B13E7-0D17-43D1-B6A9-61E368D593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3244320"/>
            <a:ext cx="59148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11299680"/>
            <a:ext cx="154296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pl-PL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pl-PL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11299680"/>
            <a:ext cx="23148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11299680"/>
            <a:ext cx="154296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pl-PL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F27265B-BE99-4E07-97D7-D2D17E20F135}" type="slidenum">
              <a:rPr b="0" lang="pl-PL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49320" y="984240"/>
          <a:ext cx="4876920" cy="8993160"/>
        </p:xfrm>
        <a:graphic>
          <a:graphicData uri="http://schemas.openxmlformats.org/drawingml/2006/table">
            <a:tbl>
              <a:tblPr/>
              <a:tblGrid>
                <a:gridCol w="800280"/>
                <a:gridCol w="1960560"/>
                <a:gridCol w="463320"/>
                <a:gridCol w="547920"/>
                <a:gridCol w="512640"/>
                <a:gridCol w="592200"/>
              </a:tblGrid>
              <a:tr h="74520">
                <a:tc rowSpan="2">
                  <a:txBody>
                    <a:bodyPr lIns="2880" rIns="2880" tIns="28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mino Acid Sequence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 rowSpan="2">
                  <a:txBody>
                    <a:bodyPr lIns="2880" rIns="2880" tIns="288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ucleotide Sequence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 gridSpan="4">
                  <a:txBody>
                    <a:bodyPr lIns="2880" rIns="2880" tIns="28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LN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74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T CD4+Teff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TA-1 CD4+Teff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T T re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TA-1 T re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YFCAASESNYQLIW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CAAGTGA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3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8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3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GAGT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5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6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7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AAAGCAACTAC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8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5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9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TGCAAGT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6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TGCAAGTGA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TGCAAGC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CATCTGA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CATCG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CAAGTGAGAGCAACTAC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CAAGTGAAAGCAAT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CAAGTGAAAGCAACTAC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CAAGC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CGCAAGT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CGCAAGTGA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TTCT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TAGT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6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TAGTGA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GTCG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GAGTGAGAGCAACTAC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GAGTGA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4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6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7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698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GAGC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CTCT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CTCTGA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CTCG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4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CTCC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CTCCGA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CAGT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CAGC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TCT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TCTGA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TCG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4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TCGGA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TCC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TCA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TCAGA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AGTCT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AGTC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AGAGT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6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AGAGCAAT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AATC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2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AAAGT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4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4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AAAGCAAT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6336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CGAGAGT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CGAGAGCAAT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C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4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59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CGA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6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4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CGAAAGCAACTAC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CGCAGCGAGT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CGCAGCAAGTGA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2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8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7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CGCAGCAAGCGA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YFCAASEGNYQLIW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GAGTGAGG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CAAGTGAGG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CAAGTGAAG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TAGTGAGG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GAGTGAGGGCAACTAC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GAGTGAAG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698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CTCGGAGG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AAGGT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AAGGG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7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7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AAGGCAACTAC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CGAGG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9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CGAAG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TGCAAGTGAGG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YFCAASDSNYQLIW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CGATAGCAAT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ATTC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TCCGATAGCAACTAC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CTCGGATAGT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GTCGGATAGCAACTAC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TTCC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CGCTAGT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TGCAAGT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TGCCAGC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CGCAAGT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TGCCTCG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CCTCG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CGCAGCATCC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TCGGATAGCAACTAC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CATCC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YFCAASASNYQLIW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CGCGGCAAGTGC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CGC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CGCCTC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CGCTAGCAACTAC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CGC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CATC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5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CCAGCAACTAC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698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CCAGCAAT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CGAGT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AGTGCTAGT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TCCGC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ATCTGC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CTCGGC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GAGCGC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GAGTGCC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GAGTGC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GTCGGC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CTAGTGCC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CGCAAGTGCG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CAAGTGCC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CAAGTGC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TGCAAGTGCA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YFCAMVDSNYQLIW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ATGGTG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7,4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YFCAVVDSNYQLIW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TGGTG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,6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,96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4,1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TAGTG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,2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,66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TTGTG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51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2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TCGTA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32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,7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TGTGGTG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0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,06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TAGTA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04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TTGTC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76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TCGTG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6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TAGTC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6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4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TGGTC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4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CGTTGTG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6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TGGTA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3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698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TGTTGTG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TAGTG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28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8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TGGTT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TGGTGGAC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1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CGTCGTG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93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TCGTCGAC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GGTCGTT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CGTGGTGGATAGT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CGCAGTCGTTGATAGCAACTAT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9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64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TACTTCTGTGCAGTCGTGGATAGCAACTACCAGTTGATCTGG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27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l-PL" sz="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,00%</a:t>
                      </a:r>
                      <a:endParaRPr b="0" lang="en-US" sz="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  <a:tr h="71280"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 lIns="2880" rIns="2880" tIns="28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880" marR="28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aeff7"/>
                    </a:solidFill>
                  </a:tcPr>
                </a:tc>
              </a:tr>
            </a:tbl>
          </a:graphicData>
        </a:graphic>
      </p:graphicFrame>
      <p:sp>
        <p:nvSpPr>
          <p:cNvPr id="42" name="pole tekstowe 4"/>
          <p:cNvSpPr/>
          <p:nvPr/>
        </p:nvSpPr>
        <p:spPr>
          <a:xfrm>
            <a:off x="237600" y="10487160"/>
            <a:ext cx="64810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Supplementary tabl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List of TCR differentially expressed among CD4+Teff and Treg cells in peripheral lymph nod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(pLN) of untreated (NT) or DTA-1 treated, tumor bearing TCRmini mic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11T09:10:58Z</dcterms:created>
  <dc:creator>E460</dc:creator>
  <dc:description/>
  <dc:language>en-US</dc:language>
  <cp:lastModifiedBy>AnnaS</cp:lastModifiedBy>
  <dcterms:modified xsi:type="dcterms:W3CDTF">2017-05-30T08:46:42Z</dcterms:modified>
  <cp:revision>5</cp:revision>
  <dc:subject/>
  <dc:title>Prezentacja programu PowerPoint</dc:title>
</cp:coreProperties>
</file>